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ACC3D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2" d="100"/>
          <a:sy n="52" d="100"/>
        </p:scale>
        <p:origin x="-210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875" y="3324225"/>
            <a:ext cx="2143125" cy="2314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2200" y="3324225"/>
            <a:ext cx="2143125" cy="2314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0" y="3324225"/>
            <a:ext cx="2143125" cy="2314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735579" y="3781424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92.4%</a:t>
            </a:r>
            <a:endParaRPr lang="en-US" sz="10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581400" y="3733800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79.75%</a:t>
            </a:r>
            <a:endParaRPr lang="en-US" sz="1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562600" y="3733800"/>
            <a:ext cx="6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5.18%</a:t>
            </a:r>
            <a:endParaRPr lang="en-US" sz="10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0" y="0"/>
            <a:ext cx="60716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esjardins, et. al., Supplementary Figure 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95400" y="685800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295400" y="2606040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295400" y="5562600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0" name="Table 19"/>
          <p:cNvGraphicFramePr>
            <a:graphicFrameLocks noGrp="1"/>
          </p:cNvGraphicFramePr>
          <p:nvPr/>
        </p:nvGraphicFramePr>
        <p:xfrm>
          <a:off x="685800" y="6048346"/>
          <a:ext cx="5410199" cy="2431733"/>
        </p:xfrm>
        <a:graphic>
          <a:graphicData uri="http://schemas.openxmlformats.org/drawingml/2006/table">
            <a:tbl>
              <a:tblPr/>
              <a:tblGrid>
                <a:gridCol w="1798109"/>
                <a:gridCol w="668157"/>
                <a:gridCol w="668157"/>
                <a:gridCol w="701349"/>
                <a:gridCol w="668157"/>
                <a:gridCol w="906270"/>
              </a:tblGrid>
              <a:tr h="201953">
                <a:tc gridSpan="6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QRT-PCR Data for Versican Isoforms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719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Cell Line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V0 Ct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V1 Ct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V2 Ct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V3 Ct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EEF1A1 Ct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719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Monolayer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28.7±1.6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27.9±3.1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6.5±1.4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3.2±3.0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18.1±1.5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8719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Ctrl siRNA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29.3±1.8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29.0±1.5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7.0±1.3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4.3±1.0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19.1±1.4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8719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VCAN siRNA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8.8±1.2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20.7±1.2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7024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Scrambled shRNA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0.4±3.5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29.6±1.8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7.0±1.2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32.7±0.9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19.5±1.5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7024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VCAN shRNAclone2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19.3±1.2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7024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VCAN shRNAclone5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 smtClean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17.8±1.7</a:t>
                      </a:r>
                      <a:endParaRPr lang="en-US" sz="100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7024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kov-3 VCAN shRNAclone6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ND**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17.0±1.5</a:t>
                      </a:r>
                      <a:endParaRPr lang="en-US" sz="1000" dirty="0"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65854" marR="65854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85800" y="8667690"/>
            <a:ext cx="541020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*Presented is an average of three independent experiments performed in triplicate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**No Ct values were measured in up to 40 cycles of QPCR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066800" y="3048000"/>
            <a:ext cx="525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Non-transfected                         Control siRNA                                 VCAN siRNA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197" t="48000" r="21049" b="20000"/>
          <a:stretch>
            <a:fillRect/>
          </a:stretch>
        </p:blipFill>
        <p:spPr bwMode="auto">
          <a:xfrm>
            <a:off x="2133600" y="1143000"/>
            <a:ext cx="2438400" cy="6096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3"/>
          <p:cNvPicPr>
            <a:picLocks noChangeAspect="1" noChangeArrowheads="1"/>
          </p:cNvPicPr>
          <p:nvPr/>
        </p:nvPicPr>
        <p:blipFill>
          <a:blip r:embed="rId6" cstate="print">
            <a:lum/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197" t="35682" r="21049" b="35772"/>
          <a:stretch>
            <a:fillRect/>
          </a:stretch>
        </p:blipFill>
        <p:spPr bwMode="auto">
          <a:xfrm>
            <a:off x="2133600" y="1828800"/>
            <a:ext cx="2438400" cy="6096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2209800" y="820579"/>
            <a:ext cx="3124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KOV-3          OVCA432      OVCAR3    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648200" y="1295400"/>
            <a:ext cx="1828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p53</a:t>
            </a:r>
          </a:p>
          <a:p>
            <a:endParaRPr lang="en-US" sz="1000" b="1" dirty="0" smtClean="0">
              <a:latin typeface="Arial" pitchFamily="34" charset="0"/>
              <a:cs typeface="Arial" pitchFamily="34" charset="0"/>
            </a:endParaRPr>
          </a:p>
          <a:p>
            <a:endParaRPr lang="en-US" sz="1000" b="1" dirty="0" smtClean="0">
              <a:latin typeface="Arial" pitchFamily="34" charset="0"/>
              <a:cs typeface="Arial" pitchFamily="34" charset="0"/>
            </a:endParaRPr>
          </a:p>
          <a:p>
            <a:endParaRPr lang="en-US" sz="1000" b="1" dirty="0" smtClean="0">
              <a:latin typeface="Arial" pitchFamily="34" charset="0"/>
              <a:cs typeface="Arial" pitchFamily="34" charset="0"/>
            </a:endParaRPr>
          </a:p>
          <a:p>
            <a:endParaRPr lang="en-US" sz="1000" b="1" dirty="0" smtClean="0">
              <a:latin typeface="Arial" pitchFamily="34" charset="0"/>
              <a:cs typeface="Arial" pitchFamily="34" charset="0"/>
            </a:endParaRPr>
          </a:p>
          <a:p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-tubuli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128190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8</TotalTime>
  <Words>142</Words>
  <Application>Microsoft Office PowerPoint</Application>
  <PresentationFormat>On-screen Show (4:3)</PresentationFormat>
  <Paragraphs>6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curi</dc:creator>
  <cp:lastModifiedBy>factadmin</cp:lastModifiedBy>
  <cp:revision>13</cp:revision>
  <dcterms:created xsi:type="dcterms:W3CDTF">2006-08-16T00:00:00Z</dcterms:created>
  <dcterms:modified xsi:type="dcterms:W3CDTF">2013-10-23T16:39:42Z</dcterms:modified>
</cp:coreProperties>
</file>